
<file path=[Content_Types].xml><?xml version="1.0" encoding="utf-8"?>
<Types xmlns="http://schemas.openxmlformats.org/package/2006/content-types">
  <Default Extension="fntdata" ContentType="application/x-fontdata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78" r:id="rId2"/>
  </p:sldIdLst>
  <p:sldSz cx="7767638" cy="10058400"/>
  <p:notesSz cx="6858000" cy="9144000"/>
  <p:embeddedFontLst>
    <p:embeddedFont>
      <p:font typeface="Aptos Narrow" panose="020B0004020202020204" pitchFamily="34" charset="0"/>
      <p:regular r:id="rId4"/>
      <p:bold r:id="rId5"/>
      <p:italic r:id="rId6"/>
      <p:boldItalic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216">
          <p15:clr>
            <a:srgbClr val="747775"/>
          </p15:clr>
        </p15:guide>
        <p15:guide id="2" orient="horz" pos="316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1" roundtripDataSignature="AMtx7mhhpzlOEt5NKzBor+6azMn5nsVcQw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1412707-7436-C1E8-E4F7-8C7A3C49224A}" name="Jennifer Sollenberger (NC)" initials="JS" userId="Jennifer Sollenberger (NC)" providerId="None"/>
  <p188:author id="{95E6C042-6BC5-BE6F-D81E-E02306B43F2B}" name="Meric-Bernstam,Funda" initials="MB" userId="S::fmeric@mdanderson.org::93eb2aa4-a862-453f-ac07-7a96bbf61352" providerId="AD"/>
  <p188:author id="{EA0D05DA-0E65-F52D-82AC-A39377BF54D7}" name="Price, Rich {GHEC~SOUTH SAN FRANCISCO}" initials="RP" userId="S::richarhp@nala.roche.com::da7f3f4b-36a6-463d-a014-3e62f009f0df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aghav,Kanwal Pratap Singh" initials="" lastIdx="15" clrIdx="0"/>
  <p:cmAuthor id="1" name="Rich Price" initials="" lastIdx="9" clrIdx="1"/>
  <p:cmAuthor id="2" name="Jessica Grindheim" initials="" lastIdx="11" clrIdx="2"/>
  <p:cmAuthor id="3" name="Meric-Bernstam,Funda" initials="" lastIdx="4" clrIdx="3"/>
  <p:cmAuthor id="4" name="Price, Rich {GHEC~SOUTH SAN FRANCISCO}" initials="" lastIdx="3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13"/>
    <p:restoredTop sz="93993"/>
  </p:normalViewPr>
  <p:slideViewPr>
    <p:cSldViewPr snapToGrid="0">
      <p:cViewPr varScale="1">
        <p:scale>
          <a:sx n="72" d="100"/>
          <a:sy n="72" d="100"/>
        </p:scale>
        <p:origin x="2904" y="126"/>
      </p:cViewPr>
      <p:guideLst>
        <p:guide pos="216"/>
        <p:guide orient="horz" pos="3168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156" d="100"/>
          <a:sy n="156" d="100"/>
        </p:scale>
        <p:origin x="4984" y="19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21" Type="http://customschemas.google.com/relationships/presentationmetadata" Target="metadata"/><Relationship Id="rId7" Type="http://schemas.openxmlformats.org/officeDocument/2006/relationships/font" Target="fonts/font4.fntdata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24" Type="http://schemas.openxmlformats.org/officeDocument/2006/relationships/viewProps" Target="viewProps.xml"/><Relationship Id="rId5" Type="http://schemas.openxmlformats.org/officeDocument/2006/relationships/font" Target="fonts/font2.fntdata"/><Relationship Id="rId23" Type="http://schemas.openxmlformats.org/officeDocument/2006/relationships/presProps" Target="presProps.xml"/><Relationship Id="rId4" Type="http://schemas.openxmlformats.org/officeDocument/2006/relationships/font" Target="fonts/font1.fntdata"/><Relationship Id="rId22" Type="http://schemas.openxmlformats.org/officeDocument/2006/relationships/commentAuthors" Target="commentAuthors.xml"/><Relationship Id="rId27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975504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1"/>
          <p:cNvSpPr txBox="1">
            <a:spLocks noGrp="1"/>
          </p:cNvSpPr>
          <p:nvPr>
            <p:ph type="title"/>
          </p:nvPr>
        </p:nvSpPr>
        <p:spPr>
          <a:xfrm>
            <a:off x="529980" y="2507618"/>
            <a:ext cx="6699588" cy="4184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97"/>
              <a:buFont typeface="Calibri"/>
              <a:buNone/>
              <a:defRPr sz="509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1"/>
          <p:cNvSpPr txBox="1">
            <a:spLocks noGrp="1"/>
          </p:cNvSpPr>
          <p:nvPr>
            <p:ph type="body" idx="1"/>
          </p:nvPr>
        </p:nvSpPr>
        <p:spPr>
          <a:xfrm>
            <a:off x="529980" y="6731215"/>
            <a:ext cx="6699588" cy="22002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699"/>
              <a:buNone/>
              <a:defRPr sz="1699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529"/>
              <a:buNone/>
              <a:defRPr sz="1529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1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1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1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2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2"/>
          <p:cNvSpPr txBox="1">
            <a:spLocks noGrp="1"/>
          </p:cNvSpPr>
          <p:nvPr>
            <p:ph type="body" idx="1"/>
          </p:nvPr>
        </p:nvSpPr>
        <p:spPr>
          <a:xfrm>
            <a:off x="534025" y="2677584"/>
            <a:ext cx="3301246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2"/>
          <p:cNvSpPr txBox="1">
            <a:spLocks noGrp="1"/>
          </p:cNvSpPr>
          <p:nvPr>
            <p:ph type="body" idx="2"/>
          </p:nvPr>
        </p:nvSpPr>
        <p:spPr>
          <a:xfrm>
            <a:off x="3932367" y="2677584"/>
            <a:ext cx="3301246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2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2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3"/>
          <p:cNvSpPr txBox="1">
            <a:spLocks noGrp="1"/>
          </p:cNvSpPr>
          <p:nvPr>
            <p:ph type="title"/>
          </p:nvPr>
        </p:nvSpPr>
        <p:spPr>
          <a:xfrm>
            <a:off x="535037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3"/>
          <p:cNvSpPr txBox="1">
            <a:spLocks noGrp="1"/>
          </p:cNvSpPr>
          <p:nvPr>
            <p:ph type="body" idx="1"/>
          </p:nvPr>
        </p:nvSpPr>
        <p:spPr>
          <a:xfrm>
            <a:off x="535038" y="2465706"/>
            <a:ext cx="3286074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 b="1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None/>
              <a:defRPr sz="1699" b="1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None/>
              <a:defRPr sz="1529" b="1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9pPr>
          </a:lstStyle>
          <a:p>
            <a:endParaRPr/>
          </a:p>
        </p:txBody>
      </p:sp>
      <p:sp>
        <p:nvSpPr>
          <p:cNvPr id="43" name="Google Shape;43;p13"/>
          <p:cNvSpPr txBox="1">
            <a:spLocks noGrp="1"/>
          </p:cNvSpPr>
          <p:nvPr>
            <p:ph type="body" idx="2"/>
          </p:nvPr>
        </p:nvSpPr>
        <p:spPr>
          <a:xfrm>
            <a:off x="535038" y="3674110"/>
            <a:ext cx="3286074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body" idx="3"/>
          </p:nvPr>
        </p:nvSpPr>
        <p:spPr>
          <a:xfrm>
            <a:off x="3932367" y="2465706"/>
            <a:ext cx="3302258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 b="1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None/>
              <a:defRPr sz="1699" b="1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None/>
              <a:defRPr sz="1529" b="1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9pPr>
          </a:lstStyle>
          <a:p>
            <a:endParaRPr/>
          </a:p>
        </p:txBody>
      </p:sp>
      <p:sp>
        <p:nvSpPr>
          <p:cNvPr id="45" name="Google Shape;45;p13"/>
          <p:cNvSpPr txBox="1">
            <a:spLocks noGrp="1"/>
          </p:cNvSpPr>
          <p:nvPr>
            <p:ph type="body" idx="4"/>
          </p:nvPr>
        </p:nvSpPr>
        <p:spPr>
          <a:xfrm>
            <a:off x="3932367" y="3674110"/>
            <a:ext cx="3302258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3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4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4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4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4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5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5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5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6"/>
          <p:cNvSpPr txBox="1">
            <a:spLocks noGrp="1"/>
          </p:cNvSpPr>
          <p:nvPr>
            <p:ph type="title"/>
          </p:nvPr>
        </p:nvSpPr>
        <p:spPr>
          <a:xfrm>
            <a:off x="535037" y="670560"/>
            <a:ext cx="2505265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18"/>
              <a:buFont typeface="Calibri"/>
              <a:buNone/>
              <a:defRPr sz="2718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6"/>
          <p:cNvSpPr txBox="1">
            <a:spLocks noGrp="1"/>
          </p:cNvSpPr>
          <p:nvPr>
            <p:ph type="body" idx="1"/>
          </p:nvPr>
        </p:nvSpPr>
        <p:spPr>
          <a:xfrm>
            <a:off x="3302258" y="1448226"/>
            <a:ext cx="3932367" cy="71479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1193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718"/>
              <a:buChar char="•"/>
              <a:defRPr sz="2718"/>
            </a:lvl1pPr>
            <a:lvl2pPr marL="914400" lvl="1" indent="-37966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379"/>
              <a:buChar char="•"/>
              <a:defRPr sz="2379"/>
            </a:lvl2pPr>
            <a:lvl3pPr marL="1371600" lvl="2" indent="-35807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039"/>
              <a:buChar char="•"/>
              <a:defRPr sz="2039"/>
            </a:lvl3pPr>
            <a:lvl4pPr marL="1828800" lvl="3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4pPr>
            <a:lvl5pPr marL="2286000" lvl="4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5pPr>
            <a:lvl6pPr marL="2743200" lvl="5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6pPr>
            <a:lvl7pPr marL="3200400" lvl="6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7pPr>
            <a:lvl8pPr marL="3657600" lvl="7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8pPr>
            <a:lvl9pPr marL="4114800" lvl="8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9pPr>
          </a:lstStyle>
          <a:p>
            <a:endParaRPr/>
          </a:p>
        </p:txBody>
      </p:sp>
      <p:sp>
        <p:nvSpPr>
          <p:cNvPr id="61" name="Google Shape;61;p16"/>
          <p:cNvSpPr txBox="1">
            <a:spLocks noGrp="1"/>
          </p:cNvSpPr>
          <p:nvPr>
            <p:ph type="body" idx="2"/>
          </p:nvPr>
        </p:nvSpPr>
        <p:spPr>
          <a:xfrm>
            <a:off x="535037" y="3017520"/>
            <a:ext cx="2505265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189"/>
              <a:buNone/>
              <a:defRPr sz="1189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019"/>
              <a:buNone/>
              <a:defRPr sz="1018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9pPr>
          </a:lstStyle>
          <a:p>
            <a:endParaRPr/>
          </a:p>
        </p:txBody>
      </p:sp>
      <p:sp>
        <p:nvSpPr>
          <p:cNvPr id="62" name="Google Shape;62;p16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6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6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7"/>
          <p:cNvSpPr txBox="1">
            <a:spLocks noGrp="1"/>
          </p:cNvSpPr>
          <p:nvPr>
            <p:ph type="title"/>
          </p:nvPr>
        </p:nvSpPr>
        <p:spPr>
          <a:xfrm>
            <a:off x="535037" y="670560"/>
            <a:ext cx="2505265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18"/>
              <a:buFont typeface="Calibri"/>
              <a:buNone/>
              <a:defRPr sz="2718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7"/>
          <p:cNvSpPr>
            <a:spLocks noGrp="1"/>
          </p:cNvSpPr>
          <p:nvPr>
            <p:ph type="pic" idx="2"/>
          </p:nvPr>
        </p:nvSpPr>
        <p:spPr>
          <a:xfrm>
            <a:off x="3302258" y="1448226"/>
            <a:ext cx="3932367" cy="7147983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7"/>
          <p:cNvSpPr txBox="1">
            <a:spLocks noGrp="1"/>
          </p:cNvSpPr>
          <p:nvPr>
            <p:ph type="body" idx="1"/>
          </p:nvPr>
        </p:nvSpPr>
        <p:spPr>
          <a:xfrm>
            <a:off x="535037" y="3017520"/>
            <a:ext cx="2505265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189"/>
              <a:buNone/>
              <a:defRPr sz="1189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019"/>
              <a:buNone/>
              <a:defRPr sz="1018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9pPr>
          </a:lstStyle>
          <a:p>
            <a:endParaRPr/>
          </a:p>
        </p:txBody>
      </p:sp>
      <p:sp>
        <p:nvSpPr>
          <p:cNvPr id="69" name="Google Shape;69;p17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7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7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8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8"/>
          <p:cNvSpPr txBox="1">
            <a:spLocks noGrp="1"/>
          </p:cNvSpPr>
          <p:nvPr>
            <p:ph type="body" idx="1"/>
          </p:nvPr>
        </p:nvSpPr>
        <p:spPr>
          <a:xfrm rot="5400000">
            <a:off x="692838" y="2518771"/>
            <a:ext cx="6381962" cy="6699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8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8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8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9"/>
          <p:cNvSpPr txBox="1">
            <a:spLocks noGrp="1"/>
          </p:cNvSpPr>
          <p:nvPr>
            <p:ph type="title"/>
          </p:nvPr>
        </p:nvSpPr>
        <p:spPr>
          <a:xfrm rot="5400000">
            <a:off x="2134150" y="3960083"/>
            <a:ext cx="8524029" cy="16748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9"/>
          <p:cNvSpPr txBox="1">
            <a:spLocks noGrp="1"/>
          </p:cNvSpPr>
          <p:nvPr>
            <p:ph type="body" idx="1"/>
          </p:nvPr>
        </p:nvSpPr>
        <p:spPr>
          <a:xfrm rot="5400000">
            <a:off x="-1264191" y="2333734"/>
            <a:ext cx="8524029" cy="49275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9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9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9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8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738"/>
              <a:buFont typeface="Calibri"/>
              <a:buNone/>
              <a:defRPr sz="373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8"/>
          <p:cNvSpPr txBox="1">
            <a:spLocks noGrp="1"/>
          </p:cNvSpPr>
          <p:nvPr>
            <p:ph type="body" idx="1"/>
          </p:nvPr>
        </p:nvSpPr>
        <p:spPr>
          <a:xfrm>
            <a:off x="534025" y="2677584"/>
            <a:ext cx="6699588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79666" algn="l" rtl="0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379"/>
              <a:buFont typeface="Arial"/>
              <a:buChar char="•"/>
              <a:defRPr sz="237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8076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039"/>
              <a:buFont typeface="Arial"/>
              <a:buChar char="•"/>
              <a:defRPr sz="203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36486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Font typeface="Arial"/>
              <a:buChar char="•"/>
              <a:defRPr sz="16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8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8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8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04F5963D-250B-A9A8-3F78-671097A0893B}"/>
              </a:ext>
            </a:extLst>
          </p:cNvPr>
          <p:cNvSpPr txBox="1"/>
          <p:nvPr/>
        </p:nvSpPr>
        <p:spPr>
          <a:xfrm>
            <a:off x="113169" y="439465"/>
            <a:ext cx="3239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</a:t>
            </a:r>
            <a:r>
              <a:rPr lang="en-US"/>
              <a:t>Table 3:  </a:t>
            </a:r>
            <a:r>
              <a:rPr lang="en-US" dirty="0"/>
              <a:t>C1D1 Variants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7544B020-4F10-C57B-FB02-0AD9167281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1146580"/>
              </p:ext>
            </p:extLst>
          </p:nvPr>
        </p:nvGraphicFramePr>
        <p:xfrm>
          <a:off x="397897" y="747243"/>
          <a:ext cx="7041130" cy="5985185"/>
        </p:xfrm>
        <a:graphic>
          <a:graphicData uri="http://schemas.openxmlformats.org/drawingml/2006/table">
            <a:tbl>
              <a:tblPr/>
              <a:tblGrid>
                <a:gridCol w="589293">
                  <a:extLst>
                    <a:ext uri="{9D8B030D-6E8A-4147-A177-3AD203B41FA5}">
                      <a16:colId xmlns:a16="http://schemas.microsoft.com/office/drawing/2014/main" val="1557297269"/>
                    </a:ext>
                  </a:extLst>
                </a:gridCol>
                <a:gridCol w="222485">
                  <a:extLst>
                    <a:ext uri="{9D8B030D-6E8A-4147-A177-3AD203B41FA5}">
                      <a16:colId xmlns:a16="http://schemas.microsoft.com/office/drawing/2014/main" val="2972891704"/>
                    </a:ext>
                  </a:extLst>
                </a:gridCol>
                <a:gridCol w="266700">
                  <a:extLst>
                    <a:ext uri="{9D8B030D-6E8A-4147-A177-3AD203B41FA5}">
                      <a16:colId xmlns:a16="http://schemas.microsoft.com/office/drawing/2014/main" val="1871939832"/>
                    </a:ext>
                  </a:extLst>
                </a:gridCol>
                <a:gridCol w="478287">
                  <a:extLst>
                    <a:ext uri="{9D8B030D-6E8A-4147-A177-3AD203B41FA5}">
                      <a16:colId xmlns:a16="http://schemas.microsoft.com/office/drawing/2014/main" val="1317148227"/>
                    </a:ext>
                  </a:extLst>
                </a:gridCol>
                <a:gridCol w="396405">
                  <a:extLst>
                    <a:ext uri="{9D8B030D-6E8A-4147-A177-3AD203B41FA5}">
                      <a16:colId xmlns:a16="http://schemas.microsoft.com/office/drawing/2014/main" val="3770263321"/>
                    </a:ext>
                  </a:extLst>
                </a:gridCol>
                <a:gridCol w="396405">
                  <a:extLst>
                    <a:ext uri="{9D8B030D-6E8A-4147-A177-3AD203B41FA5}">
                      <a16:colId xmlns:a16="http://schemas.microsoft.com/office/drawing/2014/main" val="204847392"/>
                    </a:ext>
                  </a:extLst>
                </a:gridCol>
                <a:gridCol w="300528">
                  <a:extLst>
                    <a:ext uri="{9D8B030D-6E8A-4147-A177-3AD203B41FA5}">
                      <a16:colId xmlns:a16="http://schemas.microsoft.com/office/drawing/2014/main" val="2118099079"/>
                    </a:ext>
                  </a:extLst>
                </a:gridCol>
                <a:gridCol w="364703">
                  <a:extLst>
                    <a:ext uri="{9D8B030D-6E8A-4147-A177-3AD203B41FA5}">
                      <a16:colId xmlns:a16="http://schemas.microsoft.com/office/drawing/2014/main" val="1013113467"/>
                    </a:ext>
                  </a:extLst>
                </a:gridCol>
                <a:gridCol w="510316">
                  <a:extLst>
                    <a:ext uri="{9D8B030D-6E8A-4147-A177-3AD203B41FA5}">
                      <a16:colId xmlns:a16="http://schemas.microsoft.com/office/drawing/2014/main" val="3696101237"/>
                    </a:ext>
                  </a:extLst>
                </a:gridCol>
                <a:gridCol w="396405">
                  <a:extLst>
                    <a:ext uri="{9D8B030D-6E8A-4147-A177-3AD203B41FA5}">
                      <a16:colId xmlns:a16="http://schemas.microsoft.com/office/drawing/2014/main" val="67178635"/>
                    </a:ext>
                  </a:extLst>
                </a:gridCol>
                <a:gridCol w="287052">
                  <a:extLst>
                    <a:ext uri="{9D8B030D-6E8A-4147-A177-3AD203B41FA5}">
                      <a16:colId xmlns:a16="http://schemas.microsoft.com/office/drawing/2014/main" val="1150091812"/>
                    </a:ext>
                  </a:extLst>
                </a:gridCol>
                <a:gridCol w="243008">
                  <a:extLst>
                    <a:ext uri="{9D8B030D-6E8A-4147-A177-3AD203B41FA5}">
                      <a16:colId xmlns:a16="http://schemas.microsoft.com/office/drawing/2014/main" val="4103031410"/>
                    </a:ext>
                  </a:extLst>
                </a:gridCol>
                <a:gridCol w="287052">
                  <a:extLst>
                    <a:ext uri="{9D8B030D-6E8A-4147-A177-3AD203B41FA5}">
                      <a16:colId xmlns:a16="http://schemas.microsoft.com/office/drawing/2014/main" val="2904443338"/>
                    </a:ext>
                  </a:extLst>
                </a:gridCol>
                <a:gridCol w="396405">
                  <a:extLst>
                    <a:ext uri="{9D8B030D-6E8A-4147-A177-3AD203B41FA5}">
                      <a16:colId xmlns:a16="http://schemas.microsoft.com/office/drawing/2014/main" val="1513595981"/>
                    </a:ext>
                  </a:extLst>
                </a:gridCol>
                <a:gridCol w="315910">
                  <a:extLst>
                    <a:ext uri="{9D8B030D-6E8A-4147-A177-3AD203B41FA5}">
                      <a16:colId xmlns:a16="http://schemas.microsoft.com/office/drawing/2014/main" val="4158834096"/>
                    </a:ext>
                  </a:extLst>
                </a:gridCol>
                <a:gridCol w="396405">
                  <a:extLst>
                    <a:ext uri="{9D8B030D-6E8A-4147-A177-3AD203B41FA5}">
                      <a16:colId xmlns:a16="http://schemas.microsoft.com/office/drawing/2014/main" val="946440385"/>
                    </a:ext>
                  </a:extLst>
                </a:gridCol>
                <a:gridCol w="396405">
                  <a:extLst>
                    <a:ext uri="{9D8B030D-6E8A-4147-A177-3AD203B41FA5}">
                      <a16:colId xmlns:a16="http://schemas.microsoft.com/office/drawing/2014/main" val="1055624882"/>
                    </a:ext>
                  </a:extLst>
                </a:gridCol>
                <a:gridCol w="560435">
                  <a:extLst>
                    <a:ext uri="{9D8B030D-6E8A-4147-A177-3AD203B41FA5}">
                      <a16:colId xmlns:a16="http://schemas.microsoft.com/office/drawing/2014/main" val="4166266255"/>
                    </a:ext>
                  </a:extLst>
                </a:gridCol>
                <a:gridCol w="236931">
                  <a:extLst>
                    <a:ext uri="{9D8B030D-6E8A-4147-A177-3AD203B41FA5}">
                      <a16:colId xmlns:a16="http://schemas.microsoft.com/office/drawing/2014/main" val="4517060"/>
                    </a:ext>
                  </a:extLst>
                </a:gridCol>
              </a:tblGrid>
              <a:tr h="9115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PC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R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RID1A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TM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BRAF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DK1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DKN2A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GFR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RBB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GFR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GFR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RA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T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YC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DGFRA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IK3CA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MAD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P5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atient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7285458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2.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3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14.9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4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1072V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356L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287502"/>
                  </a:ext>
                </a:extLst>
              </a:tr>
              <a:tr h="354588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876*|P1453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46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13D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88Q|V344M|E542K|E453K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339C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342*|G266E|R213*|R175H|P250L|S240G|P177_C182del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9197122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1306*|N1761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2.2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1486_G1487del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6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10.88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61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2.6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134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3644464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551V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842I|CNV foc 16.0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161T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1052033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1411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|CNV foc 4.2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115F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175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8367223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1049*|N1300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567S|E2539K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3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29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6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D998Y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299fs|P27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6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2149391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600E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73H|P278T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7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9193044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1700R|E522Q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19.8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15V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8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8030074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423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1889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2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3.9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175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9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5547910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1327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1255R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776C|CNV foc 4.9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242Y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0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5842793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236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19.8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I162N|V197M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8533430"/>
                  </a:ext>
                </a:extLst>
              </a:tr>
              <a:tr h="26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1436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2.3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21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np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 2.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770V|CNV foc 2.3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13D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196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6351018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13*|E1397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329G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13C|G12A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152V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159R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82W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6992457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1492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310F|CNV foc 18.3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117N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2.5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48W|H193L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8890770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1359*|Q1294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776V|CNV foc 16.5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241P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069657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2.67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221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6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8719607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1315*|S1465R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188D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267F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823del|CNV foc 3.7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25L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157F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7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616179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2364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79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79.2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87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496A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2.77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8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4572367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1367*|H462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3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13.8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79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278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9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3292132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3.18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0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6660768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1338*|M522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390G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448_L462del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932C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6.39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694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196P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0707980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16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48T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82W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9790736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1309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40.3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8.68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175H|V217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3346099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H1349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80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892S|CNV amp 2.46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208I|D863G|L448fs|CNV foc 22.97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199T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13D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407L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73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5619796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232R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28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43.2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2.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132N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2631432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993*|T1556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575P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5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3.1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697L|CNV foc 20.6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5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545K|CNV foc 2.8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6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849293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387P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953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600E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4.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3.3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526M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H1047R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361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91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7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8109875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1291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175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8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8764459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9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0390057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1383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545K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48Q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0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7474707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1488fs|R244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95.37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237I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2226392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155I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6046360"/>
                  </a:ext>
                </a:extLst>
              </a:tr>
              <a:tr h="97231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941*|K957N|S1495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777L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306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1510440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96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58Q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542K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175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4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9367441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Y1003C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3257056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901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565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196D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2.6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545K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67Q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6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8304601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32*|A2795T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1348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I918L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1024V||CNV foc 102.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61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175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7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9056655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58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890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3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14.8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y 2.43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8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2292848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9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90452105"/>
                  </a:ext>
                </a:extLst>
              </a:tr>
              <a:tr h="97231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99W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3.8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12V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398*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48Q|R175H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0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054796"/>
                  </a:ext>
                </a:extLst>
              </a:tr>
              <a:tr h="179573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1309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12D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175G|F270C|E286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1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3689207"/>
                  </a:ext>
                </a:extLst>
              </a:tr>
              <a:tr h="267081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1397*|N813fs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37E|K226M|CNV amp 2.6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75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545G|CNV foc 2.56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248W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2</a:t>
                      </a:r>
                    </a:p>
                  </a:txBody>
                  <a:tcPr marL="4347" marR="4347" marT="4347" marB="0" anchor="b">
                    <a:lnL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accent3">
                          <a:lumMod val="40000"/>
                          <a:lumOff val="6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00799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43595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18</TotalTime>
  <Words>498</Words>
  <Application>Microsoft Office PowerPoint</Application>
  <PresentationFormat>Custom</PresentationFormat>
  <Paragraphs>24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Aptos Narrow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Her2 ctDNA MyPathway ms</dc:title>
  <dc:creator>Price, Rich {GHEC~SOUTH SAN FRANCISCO}</dc:creator>
  <cp:lastModifiedBy>Michael Davidson</cp:lastModifiedBy>
  <cp:revision>49</cp:revision>
  <cp:lastPrinted>2024-03-19T18:17:19Z</cp:lastPrinted>
  <dcterms:created xsi:type="dcterms:W3CDTF">2023-04-27T13:05:28Z</dcterms:created>
  <dcterms:modified xsi:type="dcterms:W3CDTF">2025-04-09T15:33:29Z</dcterms:modified>
</cp:coreProperties>
</file>